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0" d="100"/>
          <a:sy n="60" d="100"/>
        </p:scale>
        <p:origin x="-234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BAC82-36E9-0343-A2BB-2373BD7AE14A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A3B04-394D-BC45-84B1-734469A86D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121480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BAC82-36E9-0343-A2BB-2373BD7AE14A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A3B04-394D-BC45-84B1-734469A86D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28691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BAC82-36E9-0343-A2BB-2373BD7AE14A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A3B04-394D-BC45-84B1-734469A86D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47343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BAC82-36E9-0343-A2BB-2373BD7AE14A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A3B04-394D-BC45-84B1-734469A86D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915915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BAC82-36E9-0343-A2BB-2373BD7AE14A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A3B04-394D-BC45-84B1-734469A86D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07906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BAC82-36E9-0343-A2BB-2373BD7AE14A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A3B04-394D-BC45-84B1-734469A86D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848530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BAC82-36E9-0343-A2BB-2373BD7AE14A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A3B04-394D-BC45-84B1-734469A86D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718380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BAC82-36E9-0343-A2BB-2373BD7AE14A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A3B04-394D-BC45-84B1-734469A86D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207882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BAC82-36E9-0343-A2BB-2373BD7AE14A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A3B04-394D-BC45-84B1-734469A86D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864334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BAC82-36E9-0343-A2BB-2373BD7AE14A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A3B04-394D-BC45-84B1-734469A86D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704575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BAC82-36E9-0343-A2BB-2373BD7AE14A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A3B04-394D-BC45-84B1-734469A86D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421143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4BAC82-36E9-0343-A2BB-2373BD7AE14A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6A3B04-394D-BC45-84B1-734469A86D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429792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52069672"/>
              </p:ext>
            </p:extLst>
          </p:nvPr>
        </p:nvGraphicFramePr>
        <p:xfrm>
          <a:off x="2635250" y="1716881"/>
          <a:ext cx="3873500" cy="1549400"/>
        </p:xfrm>
        <a:graphic>
          <a:graphicData uri="http://schemas.openxmlformats.org/drawingml/2006/table">
            <a:tbl>
              <a:tblPr/>
              <a:tblGrid>
                <a:gridCol w="825500"/>
                <a:gridCol w="825500"/>
                <a:gridCol w="2222500"/>
              </a:tblGrid>
              <a:tr h="330200">
                <a:tc gridSpan="3">
                  <a:txBody>
                    <a:bodyPr/>
                    <a:lstStyle/>
                    <a:p>
                      <a:pPr algn="l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203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ene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rimer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quence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3200"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3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NKDD1B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F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TAAGATATTGAAGCGAAGT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R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TGTAAATCCAAGCCATT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3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NKDD1B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F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GGAGCCAAACAATCAAA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3200"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R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TCAGCAACATCCACCCT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5006522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</Words>
  <Application>Microsoft Macintosh PowerPoint</Application>
  <PresentationFormat>全屏显示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Company>中南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ong Ma</dc:creator>
  <cp:lastModifiedBy>Long Ma</cp:lastModifiedBy>
  <cp:revision>1</cp:revision>
  <dcterms:created xsi:type="dcterms:W3CDTF">2018-06-04T06:25:57Z</dcterms:created>
  <dcterms:modified xsi:type="dcterms:W3CDTF">2018-06-04T06:26:12Z</dcterms:modified>
</cp:coreProperties>
</file>